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1" autoAdjust="0"/>
    <p:restoredTop sz="94660"/>
  </p:normalViewPr>
  <p:slideViewPr>
    <p:cSldViewPr snapToGrid="0">
      <p:cViewPr varScale="1">
        <p:scale>
          <a:sx n="75" d="100"/>
          <a:sy n="75" d="100"/>
        </p:scale>
        <p:origin x="1138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olidFill>
              <a:srgbClr val="000000"/>
            </a:solidFill>
            <a:ln>
              <a:solidFill>
                <a:srgbClr val="000000"/>
              </a:solidFill>
            </a:ln>
            <a:effectLst/>
          </c:spPr>
          <c:invertIfNegative val="0"/>
          <c:cat>
            <c:strRef>
              <c:f>Sheet1!$A$2:$A$3</c:f>
              <c:strCache>
                <c:ptCount val="2"/>
                <c:pt idx="0">
                  <c:v>ME</c:v>
                </c:pt>
                <c:pt idx="1">
                  <c:v>IE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0-F603-4B84-9E9E-8E8A567CE99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系列 2</c:v>
                </c:pt>
              </c:strCache>
            </c:strRef>
          </c:tx>
          <c:spPr>
            <a:solidFill>
              <a:srgbClr val="FFFFFF"/>
            </a:solidFill>
            <a:ln>
              <a:solidFill>
                <a:srgbClr val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2:$I$5</c:f>
                <c:numCache>
                  <c:formatCode>General</c:formatCode>
                  <c:ptCount val="4"/>
                  <c:pt idx="0">
                    <c:v>13.344479380000001</c:v>
                  </c:pt>
                  <c:pt idx="1">
                    <c:v>3.9088839699999998</c:v>
                  </c:pt>
                </c:numCache>
              </c:numRef>
            </c:plus>
            <c:minus>
              <c:numRef>
                <c:f>Sheet1!$I$2:$I$5</c:f>
                <c:numCache>
                  <c:formatCode>General</c:formatCode>
                  <c:ptCount val="4"/>
                  <c:pt idx="0">
                    <c:v>13.344479380000001</c:v>
                  </c:pt>
                  <c:pt idx="1">
                    <c:v>3.90888396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ME</c:v>
                </c:pt>
                <c:pt idx="1">
                  <c:v>IE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100</c:v>
                </c:pt>
                <c:pt idx="1">
                  <c:v>26.835664335664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603-4B84-9E9E-8E8A567CE9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68617088"/>
        <c:axId val="171171840"/>
      </c:barChart>
      <c:catAx>
        <c:axId val="16861708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one"/>
        <c:crossAx val="171171840"/>
        <c:crosses val="autoZero"/>
        <c:auto val="1"/>
        <c:lblAlgn val="ctr"/>
        <c:lblOffset val="100"/>
        <c:noMultiLvlLbl val="0"/>
      </c:catAx>
      <c:valAx>
        <c:axId val="171171840"/>
        <c:scaling>
          <c:orientation val="minMax"/>
          <c:max val="12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75000"/>
                </a:schemeClr>
              </a:solidFill>
              <a:prstDash val="sysDash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68617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2574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3759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362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574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2356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2202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1614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4499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5820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8485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057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B5FE24-EF5F-4F8A-A198-62F38E59BF79}" type="datetimeFigureOut">
              <a:rPr kumimoji="1" lang="ja-JP" altLang="en-US" smtClean="0"/>
              <a:t>2020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08017-1601-407F-BB48-E077B17D8A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0462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/>
          <p:nvPr>
            <p:extLst>
              <p:ext uri="{D42A27DB-BD31-4B8C-83A1-F6EECF244321}">
                <p14:modId xmlns:p14="http://schemas.microsoft.com/office/powerpoint/2010/main" val="2078668500"/>
              </p:ext>
            </p:extLst>
          </p:nvPr>
        </p:nvGraphicFramePr>
        <p:xfrm>
          <a:off x="3157397" y="2305808"/>
          <a:ext cx="3096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5085779" y="3212878"/>
            <a:ext cx="9669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5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ar = ±SD</a:t>
            </a: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915946" y="4696622"/>
            <a:ext cx="1239442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ker319-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bl1-1</a:t>
            </a: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890604" y="2121718"/>
            <a:ext cx="323165" cy="275331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>
              <a:lnSpc>
                <a:spcPct val="75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of flowers relative to Coker319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920667" y="4696622"/>
            <a:ext cx="848309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ker319</a:t>
            </a:r>
            <a:endParaRPr lang="en-US" altLang="ja-JP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右大かっこ 8"/>
          <p:cNvSpPr/>
          <p:nvPr/>
        </p:nvSpPr>
        <p:spPr>
          <a:xfrm rot="16200000">
            <a:off x="4754186" y="1850313"/>
            <a:ext cx="144000" cy="1188000"/>
          </a:xfrm>
          <a:prstGeom prst="rightBracket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4635057" y="2218844"/>
            <a:ext cx="344966" cy="2775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5000"/>
              </a:lnSpc>
            </a:pPr>
            <a:r>
              <a:rPr lang="en-US" altLang="ja-JP" sz="1600" dirty="0"/>
              <a:t>**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8C3BEDC-71F3-49E9-8F1D-FE62B5942764}"/>
              </a:ext>
            </a:extLst>
          </p:cNvPr>
          <p:cNvSpPr txBox="1"/>
          <p:nvPr/>
        </p:nvSpPr>
        <p:spPr>
          <a:xfrm>
            <a:off x="3124483" y="1994135"/>
            <a:ext cx="516247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ja-JP" altLang="en-US" sz="1200">
                <a:latin typeface="Arial"/>
                <a:ea typeface="游ゴシック"/>
                <a:cs typeface="Arial"/>
              </a:rPr>
              <a:t>(%)</a:t>
            </a:r>
            <a:endParaRPr lang="ja-JP" altLang="en-US" sz="1200" dirty="0">
              <a:latin typeface="Arial"/>
              <a:ea typeface="游ゴシック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36679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>Japan Tobacc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mano, Kaori</dc:creator>
  <cp:lastModifiedBy>Hamano, Kaori</cp:lastModifiedBy>
  <cp:revision>1</cp:revision>
  <dcterms:created xsi:type="dcterms:W3CDTF">2020-12-11T02:18:59Z</dcterms:created>
  <dcterms:modified xsi:type="dcterms:W3CDTF">2020-12-11T02:19:59Z</dcterms:modified>
</cp:coreProperties>
</file>